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37" d="100"/>
          <a:sy n="137" d="100"/>
        </p:scale>
        <p:origin x="-968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12178-9794-4B65-849B-0F4E9205AE94}" type="datetimeFigureOut">
              <a:rPr lang="en-US" smtClean="0"/>
              <a:pPr/>
              <a:t>27/0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85B0C-516C-46A3-9A2B-B1B023E7389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12178-9794-4B65-849B-0F4E9205AE94}" type="datetimeFigureOut">
              <a:rPr lang="en-US" smtClean="0"/>
              <a:pPr/>
              <a:t>27/0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85B0C-516C-46A3-9A2B-B1B023E7389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12178-9794-4B65-849B-0F4E9205AE94}" type="datetimeFigureOut">
              <a:rPr lang="en-US" smtClean="0"/>
              <a:pPr/>
              <a:t>27/0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85B0C-516C-46A3-9A2B-B1B023E7389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12178-9794-4B65-849B-0F4E9205AE94}" type="datetimeFigureOut">
              <a:rPr lang="en-US" smtClean="0"/>
              <a:pPr/>
              <a:t>27/0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85B0C-516C-46A3-9A2B-B1B023E7389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12178-9794-4B65-849B-0F4E9205AE94}" type="datetimeFigureOut">
              <a:rPr lang="en-US" smtClean="0"/>
              <a:pPr/>
              <a:t>27/0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85B0C-516C-46A3-9A2B-B1B023E7389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12178-9794-4B65-849B-0F4E9205AE94}" type="datetimeFigureOut">
              <a:rPr lang="en-US" smtClean="0"/>
              <a:pPr/>
              <a:t>27/06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85B0C-516C-46A3-9A2B-B1B023E7389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12178-9794-4B65-849B-0F4E9205AE94}" type="datetimeFigureOut">
              <a:rPr lang="en-US" smtClean="0"/>
              <a:pPr/>
              <a:t>27/06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85B0C-516C-46A3-9A2B-B1B023E7389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12178-9794-4B65-849B-0F4E9205AE94}" type="datetimeFigureOut">
              <a:rPr lang="en-US" smtClean="0"/>
              <a:pPr/>
              <a:t>27/06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85B0C-516C-46A3-9A2B-B1B023E7389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12178-9794-4B65-849B-0F4E9205AE94}" type="datetimeFigureOut">
              <a:rPr lang="en-US" smtClean="0"/>
              <a:pPr/>
              <a:t>27/06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85B0C-516C-46A3-9A2B-B1B023E7389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12178-9794-4B65-849B-0F4E9205AE94}" type="datetimeFigureOut">
              <a:rPr lang="en-US" smtClean="0"/>
              <a:pPr/>
              <a:t>27/06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85B0C-516C-46A3-9A2B-B1B023E7389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12178-9794-4B65-849B-0F4E9205AE94}" type="datetimeFigureOut">
              <a:rPr lang="en-US" smtClean="0"/>
              <a:pPr/>
              <a:t>27/06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85B0C-516C-46A3-9A2B-B1B023E7389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D12178-9794-4B65-849B-0F4E9205AE94}" type="datetimeFigureOut">
              <a:rPr lang="en-US" smtClean="0"/>
              <a:pPr/>
              <a:t>27/0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085B0C-516C-46A3-9A2B-B1B023E73891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4" Type="http://schemas.openxmlformats.org/officeDocument/2006/relationships/image" Target="../media/image3.tif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WB uncropped A.tif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304800" y="76200"/>
            <a:ext cx="3888256" cy="312420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1565910" y="1352550"/>
            <a:ext cx="1405890" cy="582930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6" name="Picture 5" descr="WB uncropped B.tif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 rot="5400000" flipH="1">
            <a:off x="2306181" y="1275220"/>
            <a:ext cx="2855238" cy="6858000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1478280" y="4015741"/>
            <a:ext cx="1219200" cy="8382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8" name="Picture 7" descr="WB uncropped C.tiff"/>
          <p:cNvPicPr>
            <a:picLocks noChangeAspect="1"/>
          </p:cNvPicPr>
          <p:nvPr/>
        </p:nvPicPr>
        <p:blipFill>
          <a:blip r:embed="rId4" cstate="print">
            <a:lum bright="10000"/>
          </a:blip>
          <a:stretch>
            <a:fillRect/>
          </a:stretch>
        </p:blipFill>
        <p:spPr>
          <a:xfrm>
            <a:off x="4419600" y="165327"/>
            <a:ext cx="4038600" cy="3035073"/>
          </a:xfrm>
          <a:prstGeom prst="rect">
            <a:avLst/>
          </a:prstGeom>
        </p:spPr>
      </p:pic>
      <p:sp>
        <p:nvSpPr>
          <p:cNvPr id="9" name="Rectangle 8"/>
          <p:cNvSpPr/>
          <p:nvPr/>
        </p:nvSpPr>
        <p:spPr>
          <a:xfrm>
            <a:off x="5909310" y="1173480"/>
            <a:ext cx="1786890" cy="582930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/>
          <p:cNvSpPr txBox="1"/>
          <p:nvPr/>
        </p:nvSpPr>
        <p:spPr>
          <a:xfrm>
            <a:off x="259080" y="6248400"/>
            <a:ext cx="67033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Times New Roman" pitchFamily="18" charset="0"/>
                <a:cs typeface="Times New Roman" pitchFamily="18" charset="0"/>
              </a:rPr>
              <a:t>Supplementary Figure 1. </a:t>
            </a:r>
            <a:r>
              <a:rPr lang="en-GB" sz="1200" dirty="0" err="1" smtClean="0">
                <a:latin typeface="Times New Roman" pitchFamily="18" charset="0"/>
                <a:cs typeface="Times New Roman" pitchFamily="18" charset="0"/>
              </a:rPr>
              <a:t>Autoradiographic</a:t>
            </a:r>
            <a:r>
              <a:rPr lang="en-GB" sz="1200" smtClean="0">
                <a:latin typeface="Times New Roman" pitchFamily="18" charset="0"/>
                <a:cs typeface="Times New Roman" pitchFamily="18" charset="0"/>
              </a:rPr>
              <a:t> films. 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Images 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used to prepare Figure 3 are indicated in red.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18</Words>
  <Application>Microsoft Macintosh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IN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alecalaura</dc:creator>
  <cp:lastModifiedBy>Paolo Peterlongo</cp:lastModifiedBy>
  <cp:revision>7</cp:revision>
  <dcterms:created xsi:type="dcterms:W3CDTF">2018-05-22T09:42:30Z</dcterms:created>
  <dcterms:modified xsi:type="dcterms:W3CDTF">2018-06-27T08:54:16Z</dcterms:modified>
</cp:coreProperties>
</file>